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23"/>
    <p:restoredTop sz="94712"/>
  </p:normalViewPr>
  <p:slideViewPr>
    <p:cSldViewPr snapToGrid="0">
      <p:cViewPr>
        <p:scale>
          <a:sx n="119" d="100"/>
          <a:sy n="119" d="100"/>
        </p:scale>
        <p:origin x="50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A2289E-FB58-55A8-4115-F0385072C0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B28460-9618-232C-0E08-E9A31E6C48D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73A68D-342E-B9D6-64B8-20557964D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85860D-BA7D-8D8E-BCC7-644E5787F9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4AE056-E78D-BBF3-092C-0C47333A3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730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7676FE-3D1B-06B2-2E2E-56BFB6DCC5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9370D1-ED5F-07AF-E52D-490DF055FC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719FF7-A6FF-4228-E0AD-AA86DE530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BF3697-F71F-0D6E-D420-CCCD6E362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EFC163-2717-CAE0-EDA0-7F25FB0F7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8052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3FAF53-81EB-283F-33EE-2BEE916ACB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F22FE3-A35A-7DF5-0965-8FA708A183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D99DBF-A476-AFBE-ED87-4E8C8F9CF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63CCB7-E119-8982-F7E5-011EA9791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663104-A542-C9E4-15B0-98BCB3D4C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219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105C05-9CD6-ABC7-3397-B8544DB63C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003EE0-0C3D-8AF7-DB9C-F6F2299CE8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6B285A-6B18-3203-EB0E-B6C710B6F1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9C15AC-90BF-8A6D-B655-DDACDFC52B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D8189F-F4FF-7174-0A92-590B9E357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614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0BE14-81F1-CF67-5938-06ABC57728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675A23-BFB9-6612-D1D6-352402CD9E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D70DE2-FE6C-5E47-5C59-BDF915525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E3BD15-5A7A-A2AC-B3C2-1E819E2C9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AC7095-79BC-7997-5B8D-C47A7C9A1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1506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5C2A42-8546-1FC8-7CC9-92FB32562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17E4D1-C43A-E6B9-5223-E319414059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A3EC15-FB63-DEAA-DF6B-257EE43B73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FDE3EB-EEBF-9764-11B5-BFD1CA4AC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DF84D6-D515-A13D-A91C-6819E4372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51E65C-6C6A-2D41-49B2-A3F53E5832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087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D5FE99-BADE-7F83-CFAD-FE0A96C54D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DEE862-CDFC-9201-FDF8-862F84B953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D8D0E6-E86A-8736-A36F-9899F4D231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36683F-E377-0041-FA7C-E0E9F8D6E0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9372DE4-E670-243A-0E1B-53C7185366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F3C8A5-5ABA-1E01-2BEA-37B6200CF7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10BB94-EE7E-F30E-F390-C928FD21D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3B407A-2698-48FD-A7A3-7BC899B1A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223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5D16A2-EB34-AF98-1994-5C88170201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65BE742-407B-C675-A19F-CFE0727C21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73058D-32AD-D648-4B66-B5BDB630F7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08E1058-F5D9-95A1-6266-829CB9E9A8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998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330C6F7-06F1-F084-6A3E-9E01A948F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6A90A0D-813D-D5D8-2CB7-9CF762BE83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70EE6E-361D-8B71-44D9-A7EB9C76D1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301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21FD5-420A-BCB8-C7AA-85939F450C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FAE006-2899-F2BE-022D-4817DC1760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D7F063-4D1E-F157-E8B3-5CFFED6242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DE2789-DD9F-2B4F-11B4-7FA1DCFE7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186D35-AC65-5626-6D8E-E1AF92EF4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C5D85A-9BB6-7E46-AB41-5AC930E4A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301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9E2762-D30D-91DE-00F5-ED290B229F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85081A7-73D9-429B-B9B2-12C3D88CD6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EAA01C-A529-5682-ED76-B6B0715530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BE8101-3606-CF0E-BF3A-5DAD4942E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E90423-112E-36AD-E4C7-730F993E4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61BD8D-A940-725F-8A40-0A780C395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025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55B365-27EE-1738-744C-0278596E85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1F2E65-5983-E1B4-3F77-83124A03F8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4318AE-24ED-148D-B2AF-EC9F826C89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716B25-6459-9D49-B32E-9005C61C06D6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E7564E-B03D-4F63-1F37-9BAEACE76C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084412-7B60-A878-8E16-35A16F3EC2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DE13E7-69D4-084B-B774-4728F7A83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648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omputer&#10;&#10;Description automatically generated">
            <a:extLst>
              <a:ext uri="{FF2B5EF4-FFF2-40B4-BE49-F238E27FC236}">
                <a16:creationId xmlns:a16="http://schemas.microsoft.com/office/drawing/2014/main" id="{5F697833-00FE-DD2E-D58F-EF1AB3B06D1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778" y="225911"/>
            <a:ext cx="8984265" cy="526317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C2B22F4-02A3-6EE2-1FC6-AB9CC43CA5AE}"/>
              </a:ext>
            </a:extLst>
          </p:cNvPr>
          <p:cNvSpPr txBox="1"/>
          <p:nvPr/>
        </p:nvSpPr>
        <p:spPr>
          <a:xfrm>
            <a:off x="604222" y="4268097"/>
            <a:ext cx="906869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S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Non-negative factorization of the counts matrices. Every chromosomal arm is represented by a matrix. Before factorization, the amplicon counts are normalized via dividing the raw counts by the total number of counts coming from each chromosomal arm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37969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5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mel Lahouel</dc:creator>
  <cp:lastModifiedBy>Kamel Lahouel</cp:lastModifiedBy>
  <cp:revision>1</cp:revision>
  <dcterms:created xsi:type="dcterms:W3CDTF">2025-02-19T22:59:50Z</dcterms:created>
  <dcterms:modified xsi:type="dcterms:W3CDTF">2025-02-19T23:03:03Z</dcterms:modified>
</cp:coreProperties>
</file>